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2" d="100"/>
          <a:sy n="112" d="100"/>
        </p:scale>
        <p:origin x="-744" y="5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Picture 1" descr="C:\Users\chuyuye\AppData\Roaming\Tencent\Users\272921624\QQ\WinTemp\RichOle\O($(OF@Q(M@%B3Q$_YWFX)0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1000" y="2344579"/>
            <a:ext cx="3023384" cy="2617286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383418" y="2143780"/>
            <a:ext cx="1207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gma-miR395b</a:t>
            </a:r>
          </a:p>
        </p:txBody>
      </p:sp>
      <p:pic>
        <p:nvPicPr>
          <p:cNvPr id="1026" name="Picture 2" descr="C:\Users\chuyuye\AppData\Roaming\Tencent\Users\272921624\QQ\WinTemp\RichOle\C47G5(8T9KXW3%BQH4MF4LJ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57600" y="2441484"/>
            <a:ext cx="2971800" cy="2493895"/>
          </a:xfrm>
          <a:prstGeom prst="rect">
            <a:avLst/>
          </a:prstGeom>
          <a:noFill/>
        </p:spPr>
      </p:pic>
      <p:sp>
        <p:nvSpPr>
          <p:cNvPr id="9" name="TextBox 8"/>
          <p:cNvSpPr txBox="1"/>
          <p:nvPr/>
        </p:nvSpPr>
        <p:spPr>
          <a:xfrm>
            <a:off x="4507618" y="2143780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 pitchFamily="49" charset="0"/>
                <a:cs typeface="Courier New" pitchFamily="49" charset="0"/>
              </a:rPr>
              <a:t>gma-miR1508b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H="1">
            <a:off x="2286000" y="3716179"/>
            <a:ext cx="762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5054600" y="4215712"/>
            <a:ext cx="76200" cy="152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371600" y="4935379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Glyma18g11683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660018" y="4935379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ourier New" pitchFamily="49" charset="0"/>
                <a:cs typeface="Courier New" pitchFamily="49" charset="0"/>
              </a:rPr>
              <a:t>Glyma18g02110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57200" y="5410200"/>
            <a:ext cx="6019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Plot signals of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argets supported by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egrad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ata. The x-axis displays the nucleotide position of the target genes while the y-axis indicates the abundance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egradom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ads. Each circle represents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egradom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ragment mapped to the target gene and the circle indicated by the red arrow represents the expecte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RN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leavage product. Targets of gma-miR395b and gma-miR1508b are shown in the left and right panels, respectively.</a:t>
            </a:r>
          </a:p>
          <a:p>
            <a:pPr algn="just"/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1.PPTX</DocumentId>
    <DocumentType xmlns="370fed10-a368-469c-a864-2e77a9536334">Presentation</DocumentType>
    <TitleName xmlns="370fed10-a368-469c-a864-2e77a9536334">Presentation 1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EDE98DC3-7082-4E72-A53D-A106C2808661}"/>
</file>

<file path=customXml/itemProps2.xml><?xml version="1.0" encoding="utf-8"?>
<ds:datastoreItem xmlns:ds="http://schemas.openxmlformats.org/officeDocument/2006/customXml" ds:itemID="{AE4085D5-D025-413D-BF5F-ED9B3E96BB2C}"/>
</file>

<file path=customXml/itemProps3.xml><?xml version="1.0" encoding="utf-8"?>
<ds:datastoreItem xmlns:ds="http://schemas.openxmlformats.org/officeDocument/2006/customXml" ds:itemID="{F9151993-CBB8-4291-B154-4A79EB747AA6}"/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8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uyuye</dc:creator>
  <cp:lastModifiedBy>chuyuye</cp:lastModifiedBy>
  <cp:revision>13</cp:revision>
  <dcterms:created xsi:type="dcterms:W3CDTF">2006-08-16T00:00:00Z</dcterms:created>
  <dcterms:modified xsi:type="dcterms:W3CDTF">2014-09-24T13:52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